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83" r:id="rId2"/>
    <p:sldId id="290" r:id="rId3"/>
    <p:sldId id="289" r:id="rId4"/>
    <p:sldId id="286" r:id="rId5"/>
    <p:sldId id="280" r:id="rId6"/>
    <p:sldId id="288" r:id="rId7"/>
    <p:sldId id="284" r:id="rId8"/>
    <p:sldId id="291" r:id="rId9"/>
  </p:sldIdLst>
  <p:sldSz cx="6858000" cy="9906000" type="A4"/>
  <p:notesSz cx="9296400" cy="7010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7252AFF-EB31-D24E-671F-C96EB362E364}" name="Céline Van Dender" initials="CVD" userId="S::Celine.VanDender@UGent.be::bbba5870-1e2d-4d6c-b878-e9078f633c85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rlotte Wallaeys" initials="CW" lastIdx="15" clrIdx="0">
    <p:extLst>
      <p:ext uri="{19B8F6BF-5375-455C-9EA6-DF929625EA0E}">
        <p15:presenceInfo xmlns:p15="http://schemas.microsoft.com/office/powerpoint/2012/main" userId="S-1-5-21-2172363267-421418527-89760246-100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ijl, lich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33" autoAdjust="0"/>
    <p:restoredTop sz="95106" autoAdjust="0"/>
  </p:normalViewPr>
  <p:slideViewPr>
    <p:cSldViewPr snapToGrid="0">
      <p:cViewPr>
        <p:scale>
          <a:sx n="60" d="100"/>
          <a:sy n="60" d="100"/>
        </p:scale>
        <p:origin x="2928" y="-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6347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B6F6C7D-324D-4BD5-BC79-ED69DCE74DB3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30638" y="876300"/>
            <a:ext cx="1635125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9640" y="3373756"/>
            <a:ext cx="7437120" cy="2760344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6347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D2804E9-5828-4E29-B7B9-0ADCD5281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09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442853A-18E2-72DE-A83F-60A06A4229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>
            <a:extLst>
              <a:ext uri="{FF2B5EF4-FFF2-40B4-BE49-F238E27FC236}">
                <a16:creationId xmlns:a16="http://schemas.microsoft.com/office/drawing/2014/main" id="{514FF6A1-0828-F3D2-84FA-D71E5B2C8EB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>
            <a:extLst>
              <a:ext uri="{FF2B5EF4-FFF2-40B4-BE49-F238E27FC236}">
                <a16:creationId xmlns:a16="http://schemas.microsoft.com/office/drawing/2014/main" id="{1AFE3574-0DB9-46F2-B90A-CB75AD1E8AE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C5E52BBD-47C6-5088-A19A-E20F6629E31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804E9-5828-4E29-B7B9-0ADCD528148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351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266BA1-278D-0033-C469-5D31640DA7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>
            <a:extLst>
              <a:ext uri="{FF2B5EF4-FFF2-40B4-BE49-F238E27FC236}">
                <a16:creationId xmlns:a16="http://schemas.microsoft.com/office/drawing/2014/main" id="{8EE8CFD4-CA8C-ACC0-CBFD-305FA14B3C9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>
            <a:extLst>
              <a:ext uri="{FF2B5EF4-FFF2-40B4-BE49-F238E27FC236}">
                <a16:creationId xmlns:a16="http://schemas.microsoft.com/office/drawing/2014/main" id="{7964FB1F-98AB-7671-1300-1FC1A228991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E4828A44-2F8D-A667-438D-EB5B960FD68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804E9-5828-4E29-B7B9-0ADCD528148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8942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6A14BA-ADF6-2F9A-2AE4-CFB505409E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>
            <a:extLst>
              <a:ext uri="{FF2B5EF4-FFF2-40B4-BE49-F238E27FC236}">
                <a16:creationId xmlns:a16="http://schemas.microsoft.com/office/drawing/2014/main" id="{3AF42338-659B-E27F-4D8F-A60E8EE3189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>
            <a:extLst>
              <a:ext uri="{FF2B5EF4-FFF2-40B4-BE49-F238E27FC236}">
                <a16:creationId xmlns:a16="http://schemas.microsoft.com/office/drawing/2014/main" id="{6890552B-7953-784F-664D-2269FA20EDB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8FC92129-EC53-AF49-B9E4-6BBC83400AA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804E9-5828-4E29-B7B9-0ADCD528148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87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806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06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397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16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05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7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53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64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273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52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639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98BBF-2415-4DCC-9AA0-930F5E95D77A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F6DE5-3520-4606-9A74-FE2B6A36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189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oleObject" Target="../embeddings/oleObject2.bin"/><Relationship Id="rId7" Type="http://schemas.openxmlformats.org/officeDocument/2006/relationships/image" Target="../media/image4.jpg"/><Relationship Id="rId12" Type="http://schemas.microsoft.com/office/2007/relationships/hdphoto" Target="../media/hdphoto2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11" Type="http://schemas.openxmlformats.org/officeDocument/2006/relationships/image" Target="../media/image7.png"/><Relationship Id="rId5" Type="http://schemas.openxmlformats.org/officeDocument/2006/relationships/oleObject" Target="../embeddings/oleObject3.bin"/><Relationship Id="rId10" Type="http://schemas.microsoft.com/office/2007/relationships/hdphoto" Target="../media/hdphoto1.wdp"/><Relationship Id="rId4" Type="http://schemas.openxmlformats.org/officeDocument/2006/relationships/image" Target="../media/image2.emf"/><Relationship Id="rId9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A778B54-7AA2-8CC5-DE86-B478B8E9DD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5">
            <a:extLst>
              <a:ext uri="{FF2B5EF4-FFF2-40B4-BE49-F238E27FC236}">
                <a16:creationId xmlns:a16="http://schemas.microsoft.com/office/drawing/2014/main" id="{5D7E8035-30DF-FA96-AB48-33E58A481C32}"/>
              </a:ext>
            </a:extLst>
          </p:cNvPr>
          <p:cNvSpPr txBox="1"/>
          <p:nvPr/>
        </p:nvSpPr>
        <p:spPr>
          <a:xfrm>
            <a:off x="230627" y="76489"/>
            <a:ext cx="1988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err="1"/>
              <a:t>Figure</a:t>
            </a:r>
            <a:r>
              <a:rPr lang="nl-BE" dirty="0"/>
              <a:t> S1</a:t>
            </a:r>
            <a:endParaRPr lang="en-GB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A7AE66D-0854-B509-F340-B6CFCDB882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451640"/>
              </p:ext>
            </p:extLst>
          </p:nvPr>
        </p:nvGraphicFramePr>
        <p:xfrm>
          <a:off x="327660" y="684847"/>
          <a:ext cx="5671087" cy="176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8335101" imgH="2584524" progId="Prism10.Document">
                  <p:embed/>
                </p:oleObj>
              </mc:Choice>
              <mc:Fallback>
                <p:oleObj name="Prism 10" r:id="rId3" imgW="8335101" imgH="258452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7660" y="684847"/>
                        <a:ext cx="5671087" cy="176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3129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2DAC6F-521E-EEAA-C13D-5A083ED782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3A78D18-11F1-6C5C-7293-A7B8DD40649D}"/>
              </a:ext>
            </a:extLst>
          </p:cNvPr>
          <p:cNvSpPr txBox="1"/>
          <p:nvPr/>
        </p:nvSpPr>
        <p:spPr>
          <a:xfrm>
            <a:off x="689810" y="696022"/>
            <a:ext cx="5502443" cy="1185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. </a:t>
            </a:r>
            <a:r>
              <a:rPr lang="nl-BE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nsistent </a:t>
            </a:r>
            <a:r>
              <a:rPr lang="nl-BE" sz="1100" b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ownregulation</a:t>
            </a:r>
            <a:r>
              <a:rPr lang="nl-BE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f </a:t>
            </a:r>
            <a:r>
              <a:rPr lang="nl-BE" sz="1100" b="1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r1i3</a:t>
            </a:r>
            <a:r>
              <a:rPr lang="nl-BE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RNA </a:t>
            </a:r>
            <a:r>
              <a:rPr lang="nl-BE" sz="1100" b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pression</a:t>
            </a:r>
            <a:r>
              <a:rPr lang="nl-BE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in CLP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ormalized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unts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f </a:t>
            </a:r>
            <a:r>
              <a:rPr lang="nl-BE" sz="11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r1i3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in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ivers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rom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6h, 8h, 10h or 24h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fter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m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r CLP 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rgery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RNA-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eq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ata). n=3/</a:t>
            </a:r>
            <a:r>
              <a:rPr lang="nl-BE" sz="11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roup</a:t>
            </a:r>
            <a:r>
              <a:rPr lang="nl-BE" sz="11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nl-BE" sz="11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s: mean ± SD. P-values were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lyzed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ith DESeq2 (Wald test). ****: P-value &lt; 0.0001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316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604DFB-656F-3D96-1347-B2E55E7677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kstvak 51">
            <a:extLst>
              <a:ext uri="{FF2B5EF4-FFF2-40B4-BE49-F238E27FC236}">
                <a16:creationId xmlns:a16="http://schemas.microsoft.com/office/drawing/2014/main" id="{E2EB43F7-BD90-F0E7-1F2B-80F9460C2185}"/>
              </a:ext>
            </a:extLst>
          </p:cNvPr>
          <p:cNvSpPr txBox="1"/>
          <p:nvPr/>
        </p:nvSpPr>
        <p:spPr>
          <a:xfrm>
            <a:off x="343918" y="517266"/>
            <a:ext cx="33337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B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kstvak 51">
            <a:extLst>
              <a:ext uri="{FF2B5EF4-FFF2-40B4-BE49-F238E27FC236}">
                <a16:creationId xmlns:a16="http://schemas.microsoft.com/office/drawing/2014/main" id="{733E5F57-D5A4-AFEA-1EE3-A09098A97FC2}"/>
              </a:ext>
            </a:extLst>
          </p:cNvPr>
          <p:cNvSpPr txBox="1"/>
          <p:nvPr/>
        </p:nvSpPr>
        <p:spPr>
          <a:xfrm>
            <a:off x="337592" y="2205133"/>
            <a:ext cx="33337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B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kstvak 35">
            <a:extLst>
              <a:ext uri="{FF2B5EF4-FFF2-40B4-BE49-F238E27FC236}">
                <a16:creationId xmlns:a16="http://schemas.microsoft.com/office/drawing/2014/main" id="{EE4B4211-EB9E-84BF-45D1-4D908EACAA8C}"/>
              </a:ext>
            </a:extLst>
          </p:cNvPr>
          <p:cNvSpPr txBox="1"/>
          <p:nvPr/>
        </p:nvSpPr>
        <p:spPr>
          <a:xfrm>
            <a:off x="230627" y="76489"/>
            <a:ext cx="1988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err="1"/>
              <a:t>Figure</a:t>
            </a:r>
            <a:r>
              <a:rPr lang="nl-BE" dirty="0"/>
              <a:t> S2</a:t>
            </a:r>
            <a:endParaRPr lang="en-GB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E209BDB-062B-DFBA-AEEF-B081A19AF8D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98218" y="2186019"/>
          <a:ext cx="2470724" cy="2059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910183" imgH="3259452" progId="Prism10.Document">
                  <p:embed/>
                </p:oleObj>
              </mc:Choice>
              <mc:Fallback>
                <p:oleObj name="Prism 10" r:id="rId3" imgW="3910183" imgH="3259452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B573632-61F8-70F1-F49A-A108AC7343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8218" y="2186019"/>
                        <a:ext cx="2470724" cy="2059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1770059-2819-DF64-97C6-252D3A56453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01473" y="2550936"/>
          <a:ext cx="1411257" cy="2220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028342" imgH="3192500" progId="Prism10.Document">
                  <p:embed/>
                </p:oleObj>
              </mc:Choice>
              <mc:Fallback>
                <p:oleObj name="Prism 10" r:id="rId5" imgW="2028342" imgH="3192500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EE2C6D7C-AB01-61D7-D688-53046C3E79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01473" y="2550936"/>
                        <a:ext cx="1411257" cy="2220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kstvak 51">
            <a:extLst>
              <a:ext uri="{FF2B5EF4-FFF2-40B4-BE49-F238E27FC236}">
                <a16:creationId xmlns:a16="http://schemas.microsoft.com/office/drawing/2014/main" id="{38927AB9-8B14-EF54-B0A0-A03DE42F5355}"/>
              </a:ext>
            </a:extLst>
          </p:cNvPr>
          <p:cNvSpPr txBox="1"/>
          <p:nvPr/>
        </p:nvSpPr>
        <p:spPr>
          <a:xfrm>
            <a:off x="343918" y="4821146"/>
            <a:ext cx="33337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B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.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1" name="Picture 30" descr="A close-up of a purple and black background&#10;&#10;AI-generated content may be incorrect.">
            <a:extLst>
              <a:ext uri="{FF2B5EF4-FFF2-40B4-BE49-F238E27FC236}">
                <a16:creationId xmlns:a16="http://schemas.microsoft.com/office/drawing/2014/main" id="{0F13B744-7092-195E-DCBA-EA3F049A5C0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" t="36474" r="4235" b="58298"/>
          <a:stretch/>
        </p:blipFill>
        <p:spPr>
          <a:xfrm flipH="1">
            <a:off x="677292" y="5866104"/>
            <a:ext cx="4403231" cy="33774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9084945-BCB9-AC49-946A-FCC9DAD9B33F}"/>
              </a:ext>
            </a:extLst>
          </p:cNvPr>
          <p:cNvCxnSpPr>
            <a:cxnSpLocks/>
          </p:cNvCxnSpPr>
          <p:nvPr/>
        </p:nvCxnSpPr>
        <p:spPr>
          <a:xfrm>
            <a:off x="820897" y="5254776"/>
            <a:ext cx="78274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A74D63E-7203-EF4C-D5DE-1C1646F22837}"/>
              </a:ext>
            </a:extLst>
          </p:cNvPr>
          <p:cNvCxnSpPr>
            <a:cxnSpLocks/>
          </p:cNvCxnSpPr>
          <p:nvPr/>
        </p:nvCxnSpPr>
        <p:spPr>
          <a:xfrm>
            <a:off x="1719087" y="5254776"/>
            <a:ext cx="82817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156011E-2E3C-75F1-9414-9AD42AD4E0C2}"/>
              </a:ext>
            </a:extLst>
          </p:cNvPr>
          <p:cNvCxnSpPr>
            <a:cxnSpLocks/>
          </p:cNvCxnSpPr>
          <p:nvPr/>
        </p:nvCxnSpPr>
        <p:spPr>
          <a:xfrm>
            <a:off x="2653173" y="5254776"/>
            <a:ext cx="50488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DAD5E46-C283-D6EE-D4A5-F93F9776E140}"/>
              </a:ext>
            </a:extLst>
          </p:cNvPr>
          <p:cNvCxnSpPr>
            <a:cxnSpLocks/>
          </p:cNvCxnSpPr>
          <p:nvPr/>
        </p:nvCxnSpPr>
        <p:spPr>
          <a:xfrm>
            <a:off x="3283616" y="5254776"/>
            <a:ext cx="48069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C9CF65A-0F66-33B8-A3A9-CC8C85980709}"/>
              </a:ext>
            </a:extLst>
          </p:cNvPr>
          <p:cNvCxnSpPr>
            <a:cxnSpLocks/>
          </p:cNvCxnSpPr>
          <p:nvPr/>
        </p:nvCxnSpPr>
        <p:spPr>
          <a:xfrm>
            <a:off x="3911514" y="5254776"/>
            <a:ext cx="108502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0012257D-E1B2-B6AC-DF72-86085CBC3A7F}"/>
              </a:ext>
            </a:extLst>
          </p:cNvPr>
          <p:cNvSpPr txBox="1"/>
          <p:nvPr/>
        </p:nvSpPr>
        <p:spPr>
          <a:xfrm>
            <a:off x="776969" y="5044410"/>
            <a:ext cx="883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000" dirty="0"/>
              <a:t>Vehicle Sham</a:t>
            </a:r>
            <a:endParaRPr lang="en-BE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D80F890-9482-5AC1-A3B4-D5521FAE1A6E}"/>
              </a:ext>
            </a:extLst>
          </p:cNvPr>
          <p:cNvSpPr txBox="1"/>
          <p:nvPr/>
        </p:nvSpPr>
        <p:spPr>
          <a:xfrm>
            <a:off x="1720345" y="5044410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000" dirty="0"/>
              <a:t>Vehicle CLP</a:t>
            </a:r>
            <a:endParaRPr lang="en-BE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EC5F578-A45B-7309-86A2-D832A9E92B2D}"/>
              </a:ext>
            </a:extLst>
          </p:cNvPr>
          <p:cNvSpPr txBox="1"/>
          <p:nvPr/>
        </p:nvSpPr>
        <p:spPr>
          <a:xfrm>
            <a:off x="2392217" y="4902491"/>
            <a:ext cx="9893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1000" dirty="0"/>
              <a:t>TCPOBOP Sham</a:t>
            </a:r>
            <a:endParaRPr lang="en-BE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D146F57-5F47-039B-E8C7-CA0D5152BA82}"/>
              </a:ext>
            </a:extLst>
          </p:cNvPr>
          <p:cNvSpPr txBox="1"/>
          <p:nvPr/>
        </p:nvSpPr>
        <p:spPr>
          <a:xfrm>
            <a:off x="3143008" y="4903153"/>
            <a:ext cx="808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1000" dirty="0"/>
              <a:t>TCPOBOP CLP</a:t>
            </a:r>
            <a:endParaRPr lang="en-BE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6670684-5374-79D6-9F43-58FC263140CE}"/>
              </a:ext>
            </a:extLst>
          </p:cNvPr>
          <p:cNvSpPr txBox="1"/>
          <p:nvPr/>
        </p:nvSpPr>
        <p:spPr>
          <a:xfrm>
            <a:off x="4094027" y="5044410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000" dirty="0"/>
              <a:t>IgG control</a:t>
            </a:r>
            <a:endParaRPr lang="en-BE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619C9EE-F5A9-BB5C-CDEE-6571DC3DFDE7}"/>
              </a:ext>
            </a:extLst>
          </p:cNvPr>
          <p:cNvSpPr txBox="1"/>
          <p:nvPr/>
        </p:nvSpPr>
        <p:spPr>
          <a:xfrm>
            <a:off x="5058751" y="5852140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000" dirty="0" err="1"/>
              <a:t>Phospho</a:t>
            </a:r>
            <a:r>
              <a:rPr lang="nl-BE" sz="1000" dirty="0"/>
              <a:t>-CAR</a:t>
            </a:r>
            <a:endParaRPr lang="en-BE" sz="1000" dirty="0"/>
          </a:p>
        </p:txBody>
      </p:sp>
      <p:pic>
        <p:nvPicPr>
          <p:cNvPr id="43" name="Picture 42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7F84018E-EBBF-47FC-5C6C-AC830766E25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3" t="65354" r="11200" b="23711"/>
          <a:stretch/>
        </p:blipFill>
        <p:spPr>
          <a:xfrm flipH="1">
            <a:off x="677289" y="5307803"/>
            <a:ext cx="4408706" cy="51343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03F64076-3FEB-2040-5576-3995330C9292}"/>
              </a:ext>
            </a:extLst>
          </p:cNvPr>
          <p:cNvSpPr txBox="1"/>
          <p:nvPr/>
        </p:nvSpPr>
        <p:spPr>
          <a:xfrm>
            <a:off x="5058751" y="556210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000" dirty="0"/>
              <a:t>CAR</a:t>
            </a:r>
            <a:endParaRPr lang="en-BE" sz="1000" dirty="0"/>
          </a:p>
        </p:txBody>
      </p:sp>
      <p:sp>
        <p:nvSpPr>
          <p:cNvPr id="2" name="Tekstvak 36">
            <a:extLst>
              <a:ext uri="{FF2B5EF4-FFF2-40B4-BE49-F238E27FC236}">
                <a16:creationId xmlns:a16="http://schemas.microsoft.com/office/drawing/2014/main" id="{E1C23B27-2326-0F83-DA48-32C931D76AD2}"/>
              </a:ext>
            </a:extLst>
          </p:cNvPr>
          <p:cNvSpPr txBox="1"/>
          <p:nvPr/>
        </p:nvSpPr>
        <p:spPr>
          <a:xfrm>
            <a:off x="1538808" y="1302869"/>
            <a:ext cx="4806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3h</a:t>
            </a:r>
          </a:p>
          <a:p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kstvak 38">
            <a:extLst>
              <a:ext uri="{FF2B5EF4-FFF2-40B4-BE49-F238E27FC236}">
                <a16:creationId xmlns:a16="http://schemas.microsoft.com/office/drawing/2014/main" id="{9F9EF843-F1B7-02AC-4075-171606651039}"/>
              </a:ext>
            </a:extLst>
          </p:cNvPr>
          <p:cNvSpPr txBox="1"/>
          <p:nvPr/>
        </p:nvSpPr>
        <p:spPr>
          <a:xfrm>
            <a:off x="1018539" y="1468472"/>
            <a:ext cx="8275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TCPOBOP Oil + DMSO (Vehicle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Rechte verbindingslijn 29">
            <a:extLst>
              <a:ext uri="{FF2B5EF4-FFF2-40B4-BE49-F238E27FC236}">
                <a16:creationId xmlns:a16="http://schemas.microsoft.com/office/drawing/2014/main" id="{C30D04F7-608E-4CEE-053E-33B5AA267073}"/>
              </a:ext>
            </a:extLst>
          </p:cNvPr>
          <p:cNvCxnSpPr>
            <a:cxnSpLocks/>
          </p:cNvCxnSpPr>
          <p:nvPr/>
        </p:nvCxnSpPr>
        <p:spPr>
          <a:xfrm flipH="1">
            <a:off x="735479" y="1337278"/>
            <a:ext cx="1" cy="13546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Tekstvak 30">
            <a:extLst>
              <a:ext uri="{FF2B5EF4-FFF2-40B4-BE49-F238E27FC236}">
                <a16:creationId xmlns:a16="http://schemas.microsoft.com/office/drawing/2014/main" id="{4A68A734-0C0B-17DB-E522-8E5653324BA8}"/>
              </a:ext>
            </a:extLst>
          </p:cNvPr>
          <p:cNvSpPr txBox="1"/>
          <p:nvPr/>
        </p:nvSpPr>
        <p:spPr>
          <a:xfrm>
            <a:off x="617831" y="1156884"/>
            <a:ext cx="364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 descr="How To Set Use Brown Mouse Lab Clipart - Cartoon Mouse Shower Curtain  Transparent PNG - 600x591 - Free Download on NicePNG">
            <a:extLst>
              <a:ext uri="{FF2B5EF4-FFF2-40B4-BE49-F238E27FC236}">
                <a16:creationId xmlns:a16="http://schemas.microsoft.com/office/drawing/2014/main" id="{5D469793-EF83-FA38-F06A-1879810859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9091" b="90909" l="10000" r="90000">
                        <a14:foregroundMark x1="39756" y1="9836" x2="49024" y2="9091"/>
                        <a14:foregroundMark x1="48780" y1="90611" x2="48780" y2="90611"/>
                        <a14:foregroundMark x1="73293" y1="90909" x2="73293" y2="90909"/>
                        <a14:foregroundMark x1="61220" y1="90164" x2="61220" y2="90164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334" y="821926"/>
            <a:ext cx="426664" cy="3491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Human Liver Clipart Transparent Background, Human Organ Liver Illustration,  Liver Clipart, Cartoon Internal Organs, Liver PNG Image For Free Download |  Anatomy images, Human clipart, Clip art">
            <a:extLst>
              <a:ext uri="{FF2B5EF4-FFF2-40B4-BE49-F238E27FC236}">
                <a16:creationId xmlns:a16="http://schemas.microsoft.com/office/drawing/2014/main" id="{25C1278C-3C3E-E436-B833-AD18E51D99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3480" y="1289777"/>
            <a:ext cx="328088" cy="328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" name="Rechte verbindingslijn 41">
            <a:extLst>
              <a:ext uri="{FF2B5EF4-FFF2-40B4-BE49-F238E27FC236}">
                <a16:creationId xmlns:a16="http://schemas.microsoft.com/office/drawing/2014/main" id="{7DD6D903-4A94-8DA1-FE1E-2B2AF42972B8}"/>
              </a:ext>
            </a:extLst>
          </p:cNvPr>
          <p:cNvCxnSpPr>
            <a:cxnSpLocks/>
          </p:cNvCxnSpPr>
          <p:nvPr/>
        </p:nvCxnSpPr>
        <p:spPr>
          <a:xfrm flipH="1">
            <a:off x="1427635" y="1337278"/>
            <a:ext cx="1" cy="13546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Tekstvak 42">
            <a:extLst>
              <a:ext uri="{FF2B5EF4-FFF2-40B4-BE49-F238E27FC236}">
                <a16:creationId xmlns:a16="http://schemas.microsoft.com/office/drawing/2014/main" id="{8002B557-D3A4-04B3-9C1A-73E0E5F7570B}"/>
              </a:ext>
            </a:extLst>
          </p:cNvPr>
          <p:cNvSpPr txBox="1"/>
          <p:nvPr/>
        </p:nvSpPr>
        <p:spPr>
          <a:xfrm>
            <a:off x="1281842" y="1172273"/>
            <a:ext cx="3640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  <a:p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kstvak 43">
            <a:extLst>
              <a:ext uri="{FF2B5EF4-FFF2-40B4-BE49-F238E27FC236}">
                <a16:creationId xmlns:a16="http://schemas.microsoft.com/office/drawing/2014/main" id="{38B6E521-CD4A-335D-AA3C-899D58BC7862}"/>
              </a:ext>
            </a:extLst>
          </p:cNvPr>
          <p:cNvSpPr txBox="1"/>
          <p:nvPr/>
        </p:nvSpPr>
        <p:spPr>
          <a:xfrm>
            <a:off x="1990840" y="1470822"/>
            <a:ext cx="662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nl-BE" sz="8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nl-B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T-qPCR</a:t>
            </a:r>
          </a:p>
        </p:txBody>
      </p:sp>
      <p:cxnSp>
        <p:nvCxnSpPr>
          <p:cNvPr id="15" name="Rechte verbindingslijn 58">
            <a:extLst>
              <a:ext uri="{FF2B5EF4-FFF2-40B4-BE49-F238E27FC236}">
                <a16:creationId xmlns:a16="http://schemas.microsoft.com/office/drawing/2014/main" id="{098B659D-5305-636F-4103-9369627B2F06}"/>
              </a:ext>
            </a:extLst>
          </p:cNvPr>
          <p:cNvCxnSpPr>
            <a:cxnSpLocks/>
          </p:cNvCxnSpPr>
          <p:nvPr/>
        </p:nvCxnSpPr>
        <p:spPr>
          <a:xfrm>
            <a:off x="736798" y="1472406"/>
            <a:ext cx="1219275" cy="0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6" name="Tekstvak 38">
            <a:extLst>
              <a:ext uri="{FF2B5EF4-FFF2-40B4-BE49-F238E27FC236}">
                <a16:creationId xmlns:a16="http://schemas.microsoft.com/office/drawing/2014/main" id="{8A3E2DCA-973E-1A0A-4A16-C16F91863AF7}"/>
              </a:ext>
            </a:extLst>
          </p:cNvPr>
          <p:cNvSpPr txBox="1"/>
          <p:nvPr/>
        </p:nvSpPr>
        <p:spPr>
          <a:xfrm>
            <a:off x="622370" y="1448588"/>
            <a:ext cx="62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  <a:p>
            <a:r>
              <a:rPr lang="nl-BE" sz="800" dirty="0">
                <a:latin typeface="Arial" panose="020B0604020202020204" pitchFamily="34" charset="0"/>
                <a:cs typeface="Arial" panose="020B0604020202020204" pitchFamily="34" charset="0"/>
              </a:rPr>
              <a:t>CLP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kstvak 51">
            <a:extLst>
              <a:ext uri="{FF2B5EF4-FFF2-40B4-BE49-F238E27FC236}">
                <a16:creationId xmlns:a16="http://schemas.microsoft.com/office/drawing/2014/main" id="{509773C5-4A6B-8BCD-AD7E-8FE2528D2CE8}"/>
              </a:ext>
            </a:extLst>
          </p:cNvPr>
          <p:cNvSpPr txBox="1"/>
          <p:nvPr/>
        </p:nvSpPr>
        <p:spPr>
          <a:xfrm>
            <a:off x="3297732" y="2202163"/>
            <a:ext cx="33337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BE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nl-B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34466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F4650D3-57DF-71E6-3091-32254D8FA41B}"/>
              </a:ext>
            </a:extLst>
          </p:cNvPr>
          <p:cNvSpPr txBox="1"/>
          <p:nvPr/>
        </p:nvSpPr>
        <p:spPr>
          <a:xfrm>
            <a:off x="689810" y="696022"/>
            <a:ext cx="5502443" cy="3168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. Trend toward reduced CAR phosphorylation in CLP following TCPOBOP treatment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A) 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were subjected to sham or CLP, and 6h later, TCPOBOP (12.5 mg/kg) or corn oil + DMSO (50%/50%) was injected intraperitoneally, followed by liver isolation 3h later.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B-D) 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AR was immunoprecipitated from total liver lysates, with rabbit GFP-IgG as a control. Both CAR (42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kDa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and phosphorylated CAR (phospho-CAR) (42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kDa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were detected by Western blot analysis using a CAR antibody and a general anti-(Ser/Tyr/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hr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hospho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tibody, respectively. The IgG controls represent pooled IgG samples for each condition (vehicle Sham, vehicle CLP, TCPOBOP Sham, TCPOBOP CLP)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s: mean ± SD. Each dot represents a single biological replicate. P-values were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lyzed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ith two-way ANOVA (B) or unpaired t-test (C). ns: nonsignificant, *: P-value &lt; 0.05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72226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B915BA-AAE5-6E13-6206-8F532655CBC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5">
            <a:extLst>
              <a:ext uri="{FF2B5EF4-FFF2-40B4-BE49-F238E27FC236}">
                <a16:creationId xmlns:a16="http://schemas.microsoft.com/office/drawing/2014/main" id="{6CDD0A42-C987-4BE2-21BA-50F8A1B190E9}"/>
              </a:ext>
            </a:extLst>
          </p:cNvPr>
          <p:cNvSpPr txBox="1"/>
          <p:nvPr/>
        </p:nvSpPr>
        <p:spPr>
          <a:xfrm>
            <a:off x="230627" y="76489"/>
            <a:ext cx="1988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err="1"/>
              <a:t>Figure</a:t>
            </a:r>
            <a:r>
              <a:rPr lang="nl-BE" dirty="0"/>
              <a:t> S3</a:t>
            </a:r>
            <a:endParaRPr lang="en-GB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966F465-1D49-2AE1-C462-CD92F4AE83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5552007"/>
              </p:ext>
            </p:extLst>
          </p:nvPr>
        </p:nvGraphicFramePr>
        <p:xfrm>
          <a:off x="387234" y="709613"/>
          <a:ext cx="5994236" cy="435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7166330" imgH="5203965" progId="Prism10.Document">
                  <p:embed/>
                </p:oleObj>
              </mc:Choice>
              <mc:Fallback>
                <p:oleObj name="Prism 10" r:id="rId3" imgW="7166330" imgH="5203965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288FCCE8-24DF-1B2D-CB9A-7B09970FE4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7234" y="709613"/>
                        <a:ext cx="5994236" cy="435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032815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A7DA737-FDF5-B10C-E1C2-3D65366EF179}"/>
              </a:ext>
            </a:extLst>
          </p:cNvPr>
          <p:cNvSpPr txBox="1"/>
          <p:nvPr/>
        </p:nvSpPr>
        <p:spPr>
          <a:xfrm>
            <a:off x="670211" y="642496"/>
            <a:ext cx="5398078" cy="28118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3. CINPA1 partially inhibits the expression of CAR target genes in mouse liver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were injected intraperitoneally (IP) with CINPA1 (12.5 mg/kg) or corn oil + DMSO (90%/10%) for 4 days. Livers were isolated on day 4 for RT-qPCR analysis of representative CAR target genes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kr1b7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irc5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cnb1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kap2l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ubb6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yp2b10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yp2c55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ndc5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sta1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stm3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mmr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lk1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and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lt1e1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normalized to housekeeping genes 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pl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</a:t>
            </a:r>
            <a:r>
              <a:rPr lang="en-GB" sz="1100" i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prt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These genes were identified from public RNA-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eq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ata from mouse livers following 4 TCPOBOP injections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s: mean ± SEM. Each dot represents a single biological replicate. P-values were 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lyzed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ith unpaired t-test. ns: nonsignificant, *: P-value &lt; 0.05, **: P-value &lt; 0.01, ****: P-value &lt; 0.0001.</a:t>
            </a:r>
            <a:endParaRPr lang="en-BE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65196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35">
            <a:extLst>
              <a:ext uri="{FF2B5EF4-FFF2-40B4-BE49-F238E27FC236}">
                <a16:creationId xmlns:a16="http://schemas.microsoft.com/office/drawing/2014/main" id="{C5F917E6-A708-AFE0-03D1-A690AD52471B}"/>
              </a:ext>
            </a:extLst>
          </p:cNvPr>
          <p:cNvSpPr txBox="1"/>
          <p:nvPr/>
        </p:nvSpPr>
        <p:spPr>
          <a:xfrm>
            <a:off x="514111" y="447721"/>
            <a:ext cx="537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100" b="1" dirty="0" err="1"/>
              <a:t>Table</a:t>
            </a:r>
            <a:r>
              <a:rPr lang="nl-BE" sz="1100" b="1" dirty="0"/>
              <a:t> S1. List of mouse primers </a:t>
            </a:r>
            <a:r>
              <a:rPr lang="nl-BE" sz="1100" b="1" dirty="0" err="1"/>
              <a:t>used</a:t>
            </a:r>
            <a:r>
              <a:rPr lang="nl-BE" sz="1100" b="1" dirty="0"/>
              <a:t> </a:t>
            </a:r>
            <a:r>
              <a:rPr lang="nl-BE" sz="1100" b="1" dirty="0" err="1"/>
              <a:t>for</a:t>
            </a:r>
            <a:r>
              <a:rPr lang="nl-BE" sz="1100" b="1" dirty="0"/>
              <a:t> RT-</a:t>
            </a:r>
            <a:r>
              <a:rPr lang="nl-BE" sz="1100" b="1" dirty="0" err="1"/>
              <a:t>qPCR</a:t>
            </a:r>
            <a:r>
              <a:rPr lang="nl-BE" sz="1100" b="1" dirty="0"/>
              <a:t> analysis.</a:t>
            </a:r>
            <a:endParaRPr lang="en-GB" sz="1100" b="1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45EA54A-959B-F174-F74F-340A0F5A5F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8981659"/>
              </p:ext>
            </p:extLst>
          </p:nvPr>
        </p:nvGraphicFramePr>
        <p:xfrm>
          <a:off x="555056" y="721517"/>
          <a:ext cx="5373153" cy="82905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24436">
                  <a:extLst>
                    <a:ext uri="{9D8B030D-6E8A-4147-A177-3AD203B41FA5}">
                      <a16:colId xmlns:a16="http://schemas.microsoft.com/office/drawing/2014/main" val="2435123344"/>
                    </a:ext>
                  </a:extLst>
                </a:gridCol>
                <a:gridCol w="2307266">
                  <a:extLst>
                    <a:ext uri="{9D8B030D-6E8A-4147-A177-3AD203B41FA5}">
                      <a16:colId xmlns:a16="http://schemas.microsoft.com/office/drawing/2014/main" val="1874458339"/>
                    </a:ext>
                  </a:extLst>
                </a:gridCol>
                <a:gridCol w="2041451">
                  <a:extLst>
                    <a:ext uri="{9D8B030D-6E8A-4147-A177-3AD203B41FA5}">
                      <a16:colId xmlns:a16="http://schemas.microsoft.com/office/drawing/2014/main" val="889879871"/>
                    </a:ext>
                  </a:extLst>
                </a:gridCol>
              </a:tblGrid>
              <a:tr h="220927">
                <a:tc>
                  <a:txBody>
                    <a:bodyPr/>
                    <a:lstStyle/>
                    <a:p>
                      <a:r>
                        <a:rPr lang="nl-BE" sz="1000" dirty="0"/>
                        <a:t>Gene</a:t>
                      </a:r>
                      <a:endParaRPr lang="en-B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BE" sz="1000" dirty="0"/>
                        <a:t>Forward primer (5’-3’)</a:t>
                      </a:r>
                      <a:endParaRPr lang="en-B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BE" sz="1000" dirty="0"/>
                        <a:t>Reverse primer (5’-3’)</a:t>
                      </a:r>
                      <a:endParaRPr lang="en-BE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639337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Aco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A ACC CAT TTG CAC ACC TT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C GTC CGT ATC TTG AGT CC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332808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Akr1b7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CC ACC CTT ATC TCA CCC A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CT CCA TTA CTA CGG GGT CTT 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463907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Aldh1a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ATACTTGTCGGATTTAGGAGGC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GGCCTATCTTCCAAATGAAC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9737888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Birc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AG GCT GGC TTC ATC CAC T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TT TTT GCT TGT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T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TGG TCT C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6148907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cnb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AG GTG CCT GTG TGT GAA C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TC AGC CCC ATC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TGC 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690999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kap2l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AG CCA AGG GAA AGC TAA AG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C TAG GCA AAA CAT GAT TGG 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315714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a4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CACCATCTATCTGGGATCTC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CCCGAAGACGATTGAGCTA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42771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b10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TCTCCTTGTGGGCTTCTT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ACACAGCATAACCACAG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166021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c29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C TGG TCG TGT TCC TAG C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T AGG CTT TGA GCC CAA ATA 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3753484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c5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AT GAT CTG GGG GTG ATT TTC A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CG ATC CTC GAT GCT CCT 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7635044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4f1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C CCA AAT GGA ATT GGT TC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CC AGG TTA GTC ACC TCC TT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688705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7a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GGATTGCTGTGGTAGTGAGC</a:t>
                      </a:r>
                      <a:endParaRPr lang="sv-SE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GTATGGAATCAACCCGTTGT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791131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Ephx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GAGACCTTACCACTTGAAGATG</a:t>
                      </a:r>
                      <a:endParaRPr lang="sv-SE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CCCGGAACCTATCTATCCTC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557975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Fmo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G ATT GCT GTA ATT GGA GCA 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G ATG TCA CCA GAC CTT TC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7845578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Fndc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TG CCA TCT CTC AGC AGA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GC CTG CAC ATG GAC GAT 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039392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Gapdh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AAGCAGGCATCTGAGG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GAAGGTGGAAGAGTGGGA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365184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Gsta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AG CCC GTG CTT CAC TAC TT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GG CAC TTG GTC AAA CAT CAA 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2990650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Gstm3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C CAA CTT TGA CCG AAG 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GT GTC CAT AAC TTG GTT CTC C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0112811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Hprt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TGTTGGATACAGGCCAGA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GTGATTCAAATCCCTGAAG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540421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Hmmr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T TGC TTG CTT CGG CTA AA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TG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TG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CAT TGA GCT TTG C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5596958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Idh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GA GAA GCC GGT AGT GGA GA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GT CTG GTC ACG GTT TGG A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8653494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Inmt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AGAGCAGGAAATCGTAAAGT</a:t>
                      </a:r>
                      <a:endParaRPr lang="sv-SE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GGGTGTAGTCAGTGACAATGA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446962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Lipa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T TCG TTT TCA CCA TTG GG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GC ATG ATT ATC TCG GTC AC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161286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Mki67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TCATTGACCGCTCCTTTAGG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TCGCCTTGATGGTTCC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9685578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Nr1i3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ATGCTGGCATGAGGAAAGA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TGCTCCTTACTCAGTTGCAC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170965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 err="1"/>
                        <a:t>Pcna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TTGAGGCACGCCTGAT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GAGACGTGAGACGAGTCCA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2900002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Pdp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CTGTGTCCTACTGGATCTTCA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AGGTTCCTACTCGTGGC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24901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Plk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TT CGC CAA ATG CTT CGA GA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AG GCT GCG GTG AAT TGA GA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54370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Rpl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TGCTGCTCTCAAGGT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GTTGTCACTGCCTCGTACT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759175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Sult1e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G GAG ACT TCT ATG CCT GAG 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CA CAA CTT CAC TAA TCC AGG T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017742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Rec8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ATGTGCTGGTAAGAGTGCAA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GTCTTCCACAAGGTACTGG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528667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Thnsl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G TGG TAC ACT AGC ACC C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CA GGC TGC GAT AGG ACA 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91602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Tubb6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AG AGG ATC AGC GTC TAC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A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A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GT CCG AAG ATG AAG TTG TCA 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22173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878173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865611-D4CF-3DB9-1345-F9E5504930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35">
            <a:extLst>
              <a:ext uri="{FF2B5EF4-FFF2-40B4-BE49-F238E27FC236}">
                <a16:creationId xmlns:a16="http://schemas.microsoft.com/office/drawing/2014/main" id="{49A4A4B8-23CC-61BA-BCA3-481A81A62FD6}"/>
              </a:ext>
            </a:extLst>
          </p:cNvPr>
          <p:cNvSpPr txBox="1"/>
          <p:nvPr/>
        </p:nvSpPr>
        <p:spPr>
          <a:xfrm>
            <a:off x="514111" y="367288"/>
            <a:ext cx="537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100" b="1" dirty="0" err="1"/>
              <a:t>Table</a:t>
            </a:r>
            <a:r>
              <a:rPr lang="nl-BE" sz="1100" b="1" dirty="0"/>
              <a:t> S2. List of human primers </a:t>
            </a:r>
            <a:r>
              <a:rPr lang="nl-BE" sz="1100" b="1" dirty="0" err="1"/>
              <a:t>used</a:t>
            </a:r>
            <a:r>
              <a:rPr lang="nl-BE" sz="1100" b="1" dirty="0"/>
              <a:t> </a:t>
            </a:r>
            <a:r>
              <a:rPr lang="nl-BE" sz="1100" b="1" dirty="0" err="1"/>
              <a:t>for</a:t>
            </a:r>
            <a:r>
              <a:rPr lang="nl-BE" sz="1100" b="1" dirty="0"/>
              <a:t> RT-</a:t>
            </a:r>
            <a:r>
              <a:rPr lang="nl-BE" sz="1100" b="1" dirty="0" err="1"/>
              <a:t>qPCR</a:t>
            </a:r>
            <a:r>
              <a:rPr lang="nl-BE" sz="1100" b="1" dirty="0"/>
              <a:t> analysis.</a:t>
            </a:r>
            <a:endParaRPr lang="en-GB" sz="1100" b="1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7A7EE99A-3814-0FE1-9B09-E6DF66EC6F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6839343"/>
              </p:ext>
            </p:extLst>
          </p:nvPr>
        </p:nvGraphicFramePr>
        <p:xfrm>
          <a:off x="555056" y="641084"/>
          <a:ext cx="5373153" cy="41452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24436">
                  <a:extLst>
                    <a:ext uri="{9D8B030D-6E8A-4147-A177-3AD203B41FA5}">
                      <a16:colId xmlns:a16="http://schemas.microsoft.com/office/drawing/2014/main" val="2435123344"/>
                    </a:ext>
                  </a:extLst>
                </a:gridCol>
                <a:gridCol w="2307266">
                  <a:extLst>
                    <a:ext uri="{9D8B030D-6E8A-4147-A177-3AD203B41FA5}">
                      <a16:colId xmlns:a16="http://schemas.microsoft.com/office/drawing/2014/main" val="1874458339"/>
                    </a:ext>
                  </a:extLst>
                </a:gridCol>
                <a:gridCol w="2041451">
                  <a:extLst>
                    <a:ext uri="{9D8B030D-6E8A-4147-A177-3AD203B41FA5}">
                      <a16:colId xmlns:a16="http://schemas.microsoft.com/office/drawing/2014/main" val="889879871"/>
                    </a:ext>
                  </a:extLst>
                </a:gridCol>
              </a:tblGrid>
              <a:tr h="220927">
                <a:tc>
                  <a:txBody>
                    <a:bodyPr/>
                    <a:lstStyle/>
                    <a:p>
                      <a:r>
                        <a:rPr lang="nl-BE" sz="1000" dirty="0"/>
                        <a:t>Gene</a:t>
                      </a:r>
                      <a:endParaRPr lang="en-B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BE" sz="1000" dirty="0"/>
                        <a:t>Forward primer (5’-3’)</a:t>
                      </a:r>
                      <a:endParaRPr lang="en-B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BE" sz="1000" dirty="0"/>
                        <a:t>Reverse primer (5’-3’)</a:t>
                      </a:r>
                      <a:endParaRPr lang="en-BE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639337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ALDH1A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ACGCCAGACTTACCTG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CTCCTCAGTTGCAGGATTAAA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53910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A6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CAAAGGCTATGGCGTGGT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TGACGGTCTCGGTGCC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667449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2B6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ACTCCTCACAGGACTC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CCAGGTGTACCGTGAAGA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03417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7A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AATTTGGTGCCAATCCT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CACAACACCTTATGGTATGAC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8870327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CYPB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GTCACCGTCAAGGTGTATT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CTGTTTTTGTAGCCAAATCC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9666944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EPHX1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TTTGCCATCTACTGGTTCAT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CTCCTCATCTGACGTTTCC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632524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FMO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CATCACACCAATGCTCAT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TCCAGTGAATCCCTCTGGG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1633221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FNDC5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GGAGGAGGATACGGAGTA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CACATGAACAGGACCA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836793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IDH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GCCACTATGCCGACAAA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CTGCCAGATAATACGGGTC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5735680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INMT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AGGGGACACGCTGATT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GTCGGAGAGAGTGATGTCTT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2169909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LIPA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CTGGACCCTGCATTCT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ACTAGGGAATCCCCAGTAAGA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646793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NR1I3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GATGCTGGCATGAGGAAA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/>
                        <a:t>TTGCTCCTTACTCAGTTGCA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7857907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PDP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GTAGACGCTTATACTCCAG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ACATGGGGAACTGTTTAGG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952696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REC8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GTGCTGGTACGAGTGCA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ATAGACGCGGATCACAC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1269442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THNSL2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TCACTGCACAAAGATTCAG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dirty="0">
                          <a:effectLst/>
                        </a:rPr>
                        <a:t>CACAGTCTTGATCGGCTCAT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726515"/>
                  </a:ext>
                </a:extLst>
              </a:tr>
              <a:tr h="166911">
                <a:tc>
                  <a:txBody>
                    <a:bodyPr/>
                    <a:lstStyle/>
                    <a:p>
                      <a:r>
                        <a:rPr lang="nl-BE" sz="1000" i="1" dirty="0"/>
                        <a:t>UBC</a:t>
                      </a:r>
                      <a:endParaRPr lang="en-BE" sz="1000" i="1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GGAAGATGGTCGTACCCTG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GTCTTGCCAGTGAGTGTCT</a:t>
                      </a: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47526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3208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8</TotalTime>
  <Words>874</Words>
  <Application>Microsoft Office PowerPoint</Application>
  <PresentationFormat>A4 Paper (210x297 mm)</PresentationFormat>
  <Paragraphs>189</Paragraphs>
  <Slides>8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Aptos</vt:lpstr>
      <vt:lpstr>Aptos Narrow</vt:lpstr>
      <vt:lpstr>Arial</vt:lpstr>
      <vt:lpstr>Calibri</vt:lpstr>
      <vt:lpstr>Calibri Light</vt:lpstr>
      <vt:lpstr>Office Theme</vt:lpstr>
      <vt:lpstr>Prism 10</vt:lpstr>
      <vt:lpstr>GraphPad 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TNF paper</dc:title>
  <dc:creator>Charlotte Wallaeys</dc:creator>
  <cp:lastModifiedBy>Céline Van Dender</cp:lastModifiedBy>
  <cp:revision>839</cp:revision>
  <cp:lastPrinted>2022-10-24T15:57:16Z</cp:lastPrinted>
  <dcterms:created xsi:type="dcterms:W3CDTF">2022-10-24T07:04:15Z</dcterms:created>
  <dcterms:modified xsi:type="dcterms:W3CDTF">2025-07-14T13:28:59Z</dcterms:modified>
</cp:coreProperties>
</file>